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84" r:id="rId4"/>
  </p:sldMasterIdLst>
  <p:notesMasterIdLst>
    <p:notesMasterId r:id="rId6"/>
  </p:notesMasterIdLst>
  <p:sldIdLst>
    <p:sldId id="264" r:id="rId5"/>
  </p:sldIdLst>
  <p:sldSz cx="16256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5124E43-9E47-DC25-D676-F9DE56834297}" name="Duerr, Heike" initials="HD" userId="S::duerrh@linical.com::8cdd6571-a4f2-468a-b783-2d1eca7a842b" providerId="AD"/>
  <p188:author id="{C14B2E58-979C-358D-6444-72CDC5F62585}" name="Yamaoka,Toshiki(山岡俊貴)" initials="俊山" userId="S::yamaoka-toshiki@linical.co.jp::b9168bd9-de3f-42db-87f4-c88a7ae4e2c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5905" autoAdjust="0"/>
  </p:normalViewPr>
  <p:slideViewPr>
    <p:cSldViewPr snapToGrid="0">
      <p:cViewPr>
        <p:scale>
          <a:sx n="75" d="100"/>
          <a:sy n="75" d="100"/>
        </p:scale>
        <p:origin x="54" y="-16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uerr, Heike" userId="8cdd6571-a4f2-468a-b783-2d1eca7a842b" providerId="ADAL" clId="{2283D6C6-DC8E-4D00-BB7E-83A8B6B9AFD4}"/>
    <pc:docChg chg="undo custSel modSld">
      <pc:chgData name="Duerr, Heike" userId="8cdd6571-a4f2-468a-b783-2d1eca7a842b" providerId="ADAL" clId="{2283D6C6-DC8E-4D00-BB7E-83A8B6B9AFD4}" dt="2024-11-13T13:52:54.034" v="6"/>
      <pc:docMkLst>
        <pc:docMk/>
      </pc:docMkLst>
      <pc:sldChg chg="modSp mod">
        <pc:chgData name="Duerr, Heike" userId="8cdd6571-a4f2-468a-b783-2d1eca7a842b" providerId="ADAL" clId="{2283D6C6-DC8E-4D00-BB7E-83A8B6B9AFD4}" dt="2024-11-13T13:52:54.034" v="6"/>
        <pc:sldMkLst>
          <pc:docMk/>
          <pc:sldMk cId="4027809298" sldId="264"/>
        </pc:sldMkLst>
        <pc:spChg chg="mod">
          <ac:chgData name="Duerr, Heike" userId="8cdd6571-a4f2-468a-b783-2d1eca7a842b" providerId="ADAL" clId="{2283D6C6-DC8E-4D00-BB7E-83A8B6B9AFD4}" dt="2024-11-13T13:52:54.034" v="6"/>
          <ac:spMkLst>
            <pc:docMk/>
            <pc:sldMk cId="4027809298" sldId="264"/>
            <ac:spMk id="14" creationId="{9538E040-D863-9B67-84D5-6158EACBF5D7}"/>
          </ac:spMkLst>
        </pc:spChg>
        <pc:spChg chg="mod">
          <ac:chgData name="Duerr, Heike" userId="8cdd6571-a4f2-468a-b783-2d1eca7a842b" providerId="ADAL" clId="{2283D6C6-DC8E-4D00-BB7E-83A8B6B9AFD4}" dt="2024-11-13T13:52:31.606" v="2" actId="14100"/>
          <ac:spMkLst>
            <pc:docMk/>
            <pc:sldMk cId="4027809298" sldId="264"/>
            <ac:spMk id="15" creationId="{BC031DB2-E9C1-C5D9-8B6A-0F23E9119159}"/>
          </ac:spMkLst>
        </pc:spChg>
      </pc:sldChg>
    </pc:docChg>
  </pc:docChgLst>
  <pc:docChgLst>
    <pc:chgData name="Duerr, Heike" userId="8cdd6571-a4f2-468a-b783-2d1eca7a842b" providerId="ADAL" clId="{54A4F293-5E2B-481F-9D80-D25F9783CF92}"/>
    <pc:docChg chg="delSld">
      <pc:chgData name="Duerr, Heike" userId="8cdd6571-a4f2-468a-b783-2d1eca7a842b" providerId="ADAL" clId="{54A4F293-5E2B-481F-9D80-D25F9783CF92}" dt="2024-11-01T12:41:17.260" v="1" actId="2696"/>
      <pc:docMkLst>
        <pc:docMk/>
      </pc:docMkLst>
      <pc:sldChg chg="del">
        <pc:chgData name="Duerr, Heike" userId="8cdd6571-a4f2-468a-b783-2d1eca7a842b" providerId="ADAL" clId="{54A4F293-5E2B-481F-9D80-D25F9783CF92}" dt="2024-11-01T12:41:13.717" v="0" actId="2696"/>
        <pc:sldMkLst>
          <pc:docMk/>
          <pc:sldMk cId="125374199" sldId="261"/>
        </pc:sldMkLst>
      </pc:sldChg>
      <pc:sldChg chg="del">
        <pc:chgData name="Duerr, Heike" userId="8cdd6571-a4f2-468a-b783-2d1eca7a842b" providerId="ADAL" clId="{54A4F293-5E2B-481F-9D80-D25F9783CF92}" dt="2024-11-01T12:41:17.260" v="1" actId="2696"/>
        <pc:sldMkLst>
          <pc:docMk/>
          <pc:sldMk cId="3571941973" sldId="263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737729865493832"/>
          <c:y val="0.13220773718192591"/>
          <c:w val="0.60016740808194668"/>
          <c:h val="0.70543958714498334"/>
        </c:manualLayout>
      </c:layout>
      <c:lineChart>
        <c:grouping val="standard"/>
        <c:varyColors val="0"/>
        <c:ser>
          <c:idx val="0"/>
          <c:order val="0"/>
          <c:tx>
            <c:strRef>
              <c:f>'表3.5.7.a1 その他の副次評価項目'!$C$42</c:f>
              <c:strCache>
                <c:ptCount val="1"/>
                <c:pt idx="0">
                  <c:v>IND/GLY/MF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表3.5.7.a1 その他の副次評価項目'!$G$42:$I$42</c:f>
                <c:numCache>
                  <c:formatCode>General</c:formatCode>
                  <c:ptCount val="3"/>
                  <c:pt idx="0">
                    <c:v>1532.5</c:v>
                  </c:pt>
                  <c:pt idx="1">
                    <c:v>1355.9</c:v>
                  </c:pt>
                  <c:pt idx="2">
                    <c:v>1215.2</c:v>
                  </c:pt>
                </c:numCache>
              </c:numRef>
            </c:plus>
            <c:minus>
              <c:numRef>
                <c:f>'表3.5.7.a1 その他の副次評価項目'!$G$42:$I$42</c:f>
                <c:numCache>
                  <c:formatCode>General</c:formatCode>
                  <c:ptCount val="3"/>
                  <c:pt idx="0">
                    <c:v>1532.5</c:v>
                  </c:pt>
                  <c:pt idx="1">
                    <c:v>1355.9</c:v>
                  </c:pt>
                  <c:pt idx="2">
                    <c:v>1215.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</c:errBars>
          <c:cat>
            <c:numRef>
              <c:f>'表3.5.7.a1 その他の副次評価項目'!$D$41:$F$41</c:f>
              <c:numCache>
                <c:formatCode>General</c:formatCode>
                <c:ptCount val="3"/>
                <c:pt idx="0">
                  <c:v>0</c:v>
                </c:pt>
                <c:pt idx="1">
                  <c:v>4</c:v>
                </c:pt>
                <c:pt idx="2">
                  <c:v>8</c:v>
                </c:pt>
              </c:numCache>
            </c:numRef>
          </c:cat>
          <c:val>
            <c:numRef>
              <c:f>'表3.5.7.a1 その他の副次評価項目'!$D$42:$F$42</c:f>
              <c:numCache>
                <c:formatCode>0.00_);[Red]\(0.00\)</c:formatCode>
                <c:ptCount val="3"/>
                <c:pt idx="0">
                  <c:v>4361.3999999999996</c:v>
                </c:pt>
                <c:pt idx="1">
                  <c:v>4040.5</c:v>
                </c:pt>
                <c:pt idx="2">
                  <c:v>4050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3FF-4EA6-A6B9-64AFD9EF2362}"/>
            </c:ext>
          </c:extLst>
        </c:ser>
        <c:ser>
          <c:idx val="1"/>
          <c:order val="1"/>
          <c:tx>
            <c:strRef>
              <c:f>'表3.5.7.a1 その他の副次評価項目'!$C$43</c:f>
              <c:strCache>
                <c:ptCount val="1"/>
                <c:pt idx="0">
                  <c:v>ICS/LABA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表3.5.7.a1 その他の副次評価項目'!$G$43:$I$43</c:f>
                <c:numCache>
                  <c:formatCode>General</c:formatCode>
                  <c:ptCount val="3"/>
                  <c:pt idx="0">
                    <c:v>1345.1</c:v>
                  </c:pt>
                  <c:pt idx="1">
                    <c:v>1325.8</c:v>
                  </c:pt>
                  <c:pt idx="2">
                    <c:v>1257.0999999999999</c:v>
                  </c:pt>
                </c:numCache>
              </c:numRef>
            </c:plus>
            <c:minus>
              <c:numRef>
                <c:f>'表3.5.7.a1 その他の副次評価項目'!$G$43:$I$43</c:f>
                <c:numCache>
                  <c:formatCode>General</c:formatCode>
                  <c:ptCount val="3"/>
                  <c:pt idx="0">
                    <c:v>1345.1</c:v>
                  </c:pt>
                  <c:pt idx="1">
                    <c:v>1325.8</c:v>
                  </c:pt>
                  <c:pt idx="2">
                    <c:v>1257.099999999999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</c:errBars>
          <c:cat>
            <c:numRef>
              <c:f>'表3.5.7.a1 その他の副次評価項目'!$D$41:$F$41</c:f>
              <c:numCache>
                <c:formatCode>General</c:formatCode>
                <c:ptCount val="3"/>
                <c:pt idx="0">
                  <c:v>0</c:v>
                </c:pt>
                <c:pt idx="1">
                  <c:v>4</c:v>
                </c:pt>
                <c:pt idx="2">
                  <c:v>8</c:v>
                </c:pt>
              </c:numCache>
            </c:numRef>
          </c:cat>
          <c:val>
            <c:numRef>
              <c:f>'表3.5.7.a1 その他の副次評価項目'!$D$43:$F$43</c:f>
              <c:numCache>
                <c:formatCode>0.00_);[Red]\(0.00\)</c:formatCode>
                <c:ptCount val="3"/>
                <c:pt idx="0">
                  <c:v>3822.9</c:v>
                </c:pt>
                <c:pt idx="1">
                  <c:v>3962.9</c:v>
                </c:pt>
                <c:pt idx="2">
                  <c:v>4079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3FF-4EA6-A6B9-64AFD9EF23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96057839"/>
        <c:axId val="1864689471"/>
      </c:lineChart>
      <c:catAx>
        <c:axId val="149605783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Meiryo UI" panose="020B0604030504040204" pitchFamily="50" charset="-128"/>
                    <a:ea typeface="Meiryo UI" panose="020B0604030504040204" pitchFamily="50" charset="-128"/>
                    <a:cs typeface="+mn-cs"/>
                  </a:defRPr>
                </a:pPr>
                <a:r>
                  <a:rPr lang="en-US"/>
                  <a:t>Week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Meiryo UI" panose="020B0604030504040204" pitchFamily="50" charset="-128"/>
                  <a:ea typeface="Meiryo UI" panose="020B0604030504040204" pitchFamily="50" charset="-128"/>
                  <a:cs typeface="+mn-cs"/>
                </a:defRPr>
              </a:pPr>
              <a:endParaRPr lang="en-DE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bg1">
                <a:lumMod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+mn-cs"/>
              </a:defRPr>
            </a:pPr>
            <a:endParaRPr lang="en-DE"/>
          </a:p>
        </c:txPr>
        <c:crossAx val="1864689471"/>
        <c:crosses val="autoZero"/>
        <c:auto val="1"/>
        <c:lblAlgn val="ctr"/>
        <c:lblOffset val="100"/>
        <c:noMultiLvlLbl val="0"/>
      </c:catAx>
      <c:valAx>
        <c:axId val="1864689471"/>
        <c:scaling>
          <c:orientation val="minMax"/>
          <c:max val="6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Meiryo UI" panose="020B0604030504040204" pitchFamily="50" charset="-128"/>
                    <a:ea typeface="Meiryo UI" panose="020B0604030504040204" pitchFamily="50" charset="-128"/>
                    <a:cs typeface="+mn-cs"/>
                  </a:defRPr>
                </a:pPr>
                <a:r>
                  <a:rPr lang="en-US" dirty="0"/>
                  <a:t>Neutrophil count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5.1612895734548317E-2"/>
              <c:y val="0.420050534374440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Meiryo UI" panose="020B0604030504040204" pitchFamily="50" charset="-128"/>
                  <a:ea typeface="Meiryo UI" panose="020B0604030504040204" pitchFamily="50" charset="-128"/>
                  <a:cs typeface="+mn-cs"/>
                </a:defRPr>
              </a:pPr>
              <a:endParaRPr lang="en-DE"/>
            </a:p>
          </c:txPr>
        </c:title>
        <c:numFmt formatCode="#,##0_ " sourceLinked="0"/>
        <c:majorTickMark val="out"/>
        <c:minorTickMark val="none"/>
        <c:tickLblPos val="nextTo"/>
        <c:spPr>
          <a:noFill/>
          <a:ln>
            <a:solidFill>
              <a:schemeClr val="bg1">
                <a:lumMod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+mn-cs"/>
              </a:defRPr>
            </a:pPr>
            <a:endParaRPr lang="en-DE"/>
          </a:p>
        </c:txPr>
        <c:crossAx val="149605783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Meiryo UI" panose="020B0604030504040204" pitchFamily="50" charset="-128"/>
              <a:ea typeface="Meiryo UI" panose="020B0604030504040204" pitchFamily="50" charset="-128"/>
              <a:cs typeface="+mn-cs"/>
            </a:defRPr>
          </a:pPr>
          <a:endParaRPr lang="en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400" b="1">
          <a:latin typeface="Meiryo UI" panose="020B0604030504040204" pitchFamily="50" charset="-128"/>
          <a:ea typeface="Meiryo UI" panose="020B0604030504040204" pitchFamily="50" charset="-128"/>
        </a:defRPr>
      </a:pPr>
      <a:endParaRPr lang="en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F8346D-DC9A-49B1-9633-AC78FA3F13C7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9CC1D2-4A95-489D-854A-F58CB62131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2271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2529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2520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0386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5348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780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67752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6069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0893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7117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9318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0357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A07D3-8638-4676-A2CE-C8CBEE1E0AD6}" type="datetimeFigureOut">
              <a:rPr kumimoji="1" lang="ja-JP" altLang="en-US" smtClean="0"/>
              <a:t>2024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357958-6F48-47BB-99D9-4F26FEFC2D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7855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DE0B88B-94F8-362F-C00D-EFB304753D4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9538E040-D863-9B67-84D5-6158EACBF5D7}"/>
              </a:ext>
            </a:extLst>
          </p:cNvPr>
          <p:cNvSpPr txBox="1"/>
          <p:nvPr/>
        </p:nvSpPr>
        <p:spPr>
          <a:xfrm>
            <a:off x="566066" y="8633801"/>
            <a:ext cx="104448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q-AL" sz="1000" dirty="0">
                <a:latin typeface="Arial" panose="020B0604020202020204" pitchFamily="34" charset="0"/>
                <a:cs typeface="Arial" panose="020B0604020202020204" pitchFamily="34" charset="0"/>
              </a:rPr>
              <a:t>ICS/LABA = inhaled corticosteroid and long-acting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-2 -</a:t>
            </a:r>
            <a:r>
              <a:rPr lang="sq-AL" sz="1000" dirty="0">
                <a:latin typeface="Arial" panose="020B0604020202020204" pitchFamily="34" charset="0"/>
                <a:cs typeface="Arial" panose="020B0604020202020204" pitchFamily="34" charset="0"/>
              </a:rPr>
              <a:t>agonist treatment group; IND/GLY/MF = indacaterol, glycopyrronium and mometasone furoate </a:t>
            </a:r>
            <a:r>
              <a:rPr lang="sq-AL" sz="1000">
                <a:latin typeface="Arial" panose="020B0604020202020204" pitchFamily="34" charset="0"/>
                <a:cs typeface="Arial" panose="020B0604020202020204" pitchFamily="34" charset="0"/>
              </a:rPr>
              <a:t>treatment group; SD = standard deviation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C031DB2-E9C1-C5D9-8B6A-0F23E9119159}"/>
              </a:ext>
            </a:extLst>
          </p:cNvPr>
          <p:cNvSpPr txBox="1"/>
          <p:nvPr/>
        </p:nvSpPr>
        <p:spPr>
          <a:xfrm>
            <a:off x="566065" y="827062"/>
            <a:ext cx="104448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800"/>
              </a:spcAft>
            </a:pPr>
            <a:r>
              <a:rPr lang="en-US" sz="1400" b="1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Figure E3:  </a:t>
            </a:r>
            <a:r>
              <a:rPr lang="en-US" sz="1400" b="1" kern="1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Change of Neutrophil Count from Baseline to Week 8 (+/-SD) </a:t>
            </a:r>
          </a:p>
        </p:txBody>
      </p:sp>
      <p:graphicFrame>
        <p:nvGraphicFramePr>
          <p:cNvPr id="2" name="グラフ 6">
            <a:extLst>
              <a:ext uri="{FF2B5EF4-FFF2-40B4-BE49-F238E27FC236}">
                <a16:creationId xmlns:a16="http://schemas.microsoft.com/office/drawing/2014/main" id="{593D6300-3488-CB7A-9C58-BE51942157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3072359"/>
              </p:ext>
            </p:extLst>
          </p:nvPr>
        </p:nvGraphicFramePr>
        <p:xfrm>
          <a:off x="566065" y="1535537"/>
          <a:ext cx="10444835" cy="66178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027809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1A98E173E759814BB3F3B96A250EC773" ma:contentTypeVersion="12" ma:contentTypeDescription="新しいドキュメントを作成します。" ma:contentTypeScope="" ma:versionID="bde33ef34d329e68d33b323ef2d55284">
  <xsd:schema xmlns:xsd="http://www.w3.org/2001/XMLSchema" xmlns:xs="http://www.w3.org/2001/XMLSchema" xmlns:p="http://schemas.microsoft.com/office/2006/metadata/properties" xmlns:ns2="cefcc686-de10-4eef-a4db-fca3c0473b60" xmlns:ns3="85d04030-75d7-4d1f-b989-a8ee72a8c171" targetNamespace="http://schemas.microsoft.com/office/2006/metadata/properties" ma:root="true" ma:fieldsID="78174574ef3f56dfebbef9accf5d08b4" ns2:_="" ns3:_="">
    <xsd:import namespace="cefcc686-de10-4eef-a4db-fca3c0473b60"/>
    <xsd:import namespace="85d04030-75d7-4d1f-b989-a8ee72a8c171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SearchProperties" minOccurs="0"/>
                <xsd:element ref="ns3:lcf76f155ced4ddcb4097134ff3c332f" minOccurs="0"/>
                <xsd:element ref="ns2:TaxCatchAll" minOccurs="0"/>
                <xsd:element ref="ns3:MediaServiceGenerationTime" minOccurs="0"/>
                <xsd:element ref="ns3:MediaServiceEventHashCode" minOccurs="0"/>
                <xsd:element ref="ns3:MediaServiceObjectDetectorVersions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efcc686-de10-4eef-a4db-fca3c0473b60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TaxCatchAll" ma:index="15" nillable="true" ma:displayName="Taxonomy Catch All Column" ma:hidden="true" ma:list="{5bb6d219-e8e8-4975-94a0-f53f1f8c1994}" ma:internalName="TaxCatchAll" ma:showField="CatchAllData" ma:web="cefcc686-de10-4eef-a4db-fca3c0473b6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5d04030-75d7-4d1f-b989-a8ee72a8c17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2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lcf76f155ced4ddcb4097134ff3c332f" ma:index="14" nillable="true" ma:taxonomy="true" ma:internalName="lcf76f155ced4ddcb4097134ff3c332f" ma:taxonomyFieldName="MediaServiceImageTags" ma:displayName="画像タグ" ma:readOnly="false" ma:fieldId="{5cf76f15-5ced-4ddc-b409-7134ff3c332f}" ma:taxonomyMulti="true" ma:sspId="78d720a8-0ee8-4153-91e7-898845c85976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cefcc686-de10-4eef-a4db-fca3c0473b60" xsi:nil="true"/>
    <lcf76f155ced4ddcb4097134ff3c332f xmlns="85d04030-75d7-4d1f-b989-a8ee72a8c171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4000308D-6391-4F76-BEE8-CB246B947AAB}"/>
</file>

<file path=customXml/itemProps2.xml><?xml version="1.0" encoding="utf-8"?>
<ds:datastoreItem xmlns:ds="http://schemas.openxmlformats.org/officeDocument/2006/customXml" ds:itemID="{A23358A2-C544-4283-AD84-64CD8ADD3FA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57245D4-60B5-455D-BCF3-4057C2410AE0}">
  <ds:schemaRefs>
    <ds:schemaRef ds:uri="cefcc686-de10-4eef-a4db-fca3c0473b60"/>
    <ds:schemaRef ds:uri="http://schemas.microsoft.com/office/2006/metadata/properties"/>
    <ds:schemaRef ds:uri="http://schemas.microsoft.com/office/infopath/2007/PartnerControls"/>
    <ds:schemaRef ds:uri="http://purl.org/dc/elements/1.1/"/>
    <ds:schemaRef ds:uri="http://purl.org/dc/terms/"/>
    <ds:schemaRef ds:uri="http://schemas.microsoft.com/office/2006/documentManagement/types"/>
    <ds:schemaRef ds:uri="http://www.w3.org/XML/1998/namespace"/>
    <ds:schemaRef ds:uri="http://purl.org/dc/dcmitype/"/>
    <ds:schemaRef ds:uri="http://schemas.openxmlformats.org/package/2006/metadata/core-properties"/>
    <ds:schemaRef ds:uri="85d04030-75d7-4d1f-b989-a8ee72a8c171"/>
    <ds:schemaRef ds:uri="bbaeece4-e6c8-4eaf-8cf0-02d8e2ecbf0d"/>
    <ds:schemaRef ds:uri="0a1b684e-aacc-43db-87c8-a26eb42759ac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142</TotalTime>
  <Words>51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2013 - 2022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moto,Mone(松本萌音)</dc:creator>
  <cp:lastModifiedBy>Duerr, Heike</cp:lastModifiedBy>
  <cp:revision>83</cp:revision>
  <dcterms:created xsi:type="dcterms:W3CDTF">2021-06-29T02:41:29Z</dcterms:created>
  <dcterms:modified xsi:type="dcterms:W3CDTF">2024-11-13T13:52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A98E173E759814BB3F3B96A250EC773</vt:lpwstr>
  </property>
  <property fmtid="{D5CDD505-2E9C-101B-9397-08002B2CF9AE}" pid="3" name="Order">
    <vt:r8>100</vt:r8>
  </property>
  <property fmtid="{D5CDD505-2E9C-101B-9397-08002B2CF9AE}" pid="4" name="MediaServiceImageTags">
    <vt:lpwstr/>
  </property>
  <property fmtid="{D5CDD505-2E9C-101B-9397-08002B2CF9AE}" pid="5" name="_ExtendedDescription">
    <vt:lpwstr/>
  </property>
</Properties>
</file>